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3" r:id="rId3"/>
    <p:sldId id="264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495"/>
    <p:restoredTop sz="94665"/>
  </p:normalViewPr>
  <p:slideViewPr>
    <p:cSldViewPr snapToGrid="0">
      <p:cViewPr varScale="1">
        <p:scale>
          <a:sx n="107" d="100"/>
          <a:sy n="107" d="100"/>
        </p:scale>
        <p:origin x="2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F300197-1C52-239F-58D1-7B799D033F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A2F42AF-2F6B-3DD3-EF83-A3FC96A69F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AD078-5AC2-F05D-0AE0-18A48A164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56BD47E-A10A-A834-35A6-666E0D8FC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50A187-BE81-C99F-DB11-D4FEC90A7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5184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9B3BBDB-8746-7DF2-0F5E-D8A9E3BFDA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2156F8F-0AD4-356A-9E4B-3CA181DE8A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4446019-A8BD-FFFD-A4CB-4BF31094B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E8BF8EB-B8E2-350B-5040-1102C8C89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DE561B-63DF-2AB1-6AD4-7331D9B65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7275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5083E57-E864-DF49-BDD8-593EAEC01A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83D4257-816D-721D-288E-1BFEDA5566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8DC81C7-5673-6F89-178B-458F1CF1C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FBC50C2-5255-90A4-19BE-2FB2F3175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6B35AC-18C6-E265-0394-4B50ED8CA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3276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4F3506A-CF5D-A464-2F10-18AB0C414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21748C-82B9-8846-426B-9F7862B4B6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CE16080-843A-4486-B4B2-2FBDA1C36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78BD9E9-389A-37F0-E9C5-D0F756479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E80E9EC-B00C-0978-01C3-7EE0EFBAB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2750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F84EA0-DCD5-A6D9-7F59-B412FC27EE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059D39C-4948-0453-79B8-9287E32D31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5D2CFF7-7F3B-BE1E-369B-F4FD9CC8F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A0D135-DFCE-E768-49EA-7C9619B32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792B37F-81E9-C12E-0D2C-0A3C5AB5D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8201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9CD529-F1DF-C9CA-FE8E-3944A2C6A4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DC9947C-86F3-0CD5-C9EF-F7AD0CA0D2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28CE1AF-3C9A-0015-FFA5-1823292948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1DF2774-49C7-B186-3228-D57391F0E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277A117-EABE-2825-8420-3FF5A2237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DA81915-6362-305D-35FE-9D5E406D5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4896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B2345D-4537-D5B9-E255-DC517C8208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EEC183F-4783-230B-5337-7C080D1B87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0758554-E9DC-0D77-4669-C511651B96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713CFA1-D7A2-D353-B590-A17E8191AB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5DF9AB6-3FD4-8A82-0BE9-F98AA72CD2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227834E-CE47-DD1F-46C5-1F8CAFD16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87339FF-8EDC-B9B0-CEA2-81F76222D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52881E-D1F5-1D6E-9120-7083D86FA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287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9907CA-620E-E625-9C0A-33DEB816F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9311FA9-10D0-F1A5-6539-D98A2BCD8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472C3EE-F581-066B-4A6C-505FAF715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7760B64-08F2-5B8E-EB67-DCCBA65B4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3482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A357D23-C8A4-7B75-1F99-7C7A5D1F8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A188B1F-FA50-81C5-9A5C-4180431C1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5CF532C-50FD-18BB-0D29-21A068C0F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92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6160D20-75E5-DFE6-37BE-184735A8C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656D18A-DB24-5D6B-7C33-24CDE8CA9C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2F1BCB2-F1C6-A79C-6E5E-CC941009FF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9F2BDD9-9322-E54C-8220-BD74AF482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D46274F-9951-8897-F016-DA9329B6A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A471955-CCEA-6228-0A43-9A3B935C1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8444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FAF4CB-1142-45ED-0E69-5BB5B14D4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D1B17CA-A2C0-4898-C174-8084D8EF8F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9F923AE-DD33-BC80-4F29-A3A7EFF19E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0C93472-D75E-1A57-30E4-B9772E835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FFF44A6-8346-21BB-BFF8-221BFF8FF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4AC991D-78BD-E2C9-7CFA-32BF8EA5A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8168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343CCBF-9FCB-5F63-9F43-6CD1C668E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C70228F-DE8D-A18E-F7C1-DA62D0CAD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5A6488-53A9-8AD9-4C7A-2BFA696EF9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AF053-9AD4-D44B-BAA1-E6FAE369F6A2}" type="datetimeFigureOut">
              <a:rPr lang="it-IT" smtClean="0"/>
              <a:t>06/07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C175D0F-FECE-573D-0395-D07728E2E3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B3FA245-A797-FC62-CCF4-894A646185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4BF7-542A-1041-83B8-A3C5F0BB8A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967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3AAD29C-903E-8F82-DBE0-F6BD29024DE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E4B063B9-F73B-6495-942B-EFE714D5282C}"/>
              </a:ext>
            </a:extLst>
          </p:cNvPr>
          <p:cNvSpPr txBox="1"/>
          <p:nvPr/>
        </p:nvSpPr>
        <p:spPr>
          <a:xfrm>
            <a:off x="52613" y="6420758"/>
            <a:ext cx="248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</a:p>
        </p:txBody>
      </p:sp>
      <p:pic>
        <p:nvPicPr>
          <p:cNvPr id="3" name="Immagine 2" descr="Immagine che contiene diagramma, cerchio, linea&#10;&#10;Descrizione generata automaticamente">
            <a:extLst>
              <a:ext uri="{FF2B5EF4-FFF2-40B4-BE49-F238E27FC236}">
                <a16:creationId xmlns:a16="http://schemas.microsoft.com/office/drawing/2014/main" id="{C28B58FC-6189-7A1B-15B8-014B459A6BE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197" t="3580" r="20202" b="2939"/>
          <a:stretch/>
        </p:blipFill>
        <p:spPr>
          <a:xfrm>
            <a:off x="2541814" y="375557"/>
            <a:ext cx="7190016" cy="6126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6161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EEFF7B2-2523-BCBE-67CE-AE5AFCB20B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4A548930-E2E9-CA9D-7A23-7EF1A0BBBA4E}"/>
              </a:ext>
            </a:extLst>
          </p:cNvPr>
          <p:cNvSpPr txBox="1"/>
          <p:nvPr/>
        </p:nvSpPr>
        <p:spPr>
          <a:xfrm>
            <a:off x="52613" y="6420758"/>
            <a:ext cx="295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A</a:t>
            </a:r>
          </a:p>
        </p:txBody>
      </p:sp>
      <p:pic>
        <p:nvPicPr>
          <p:cNvPr id="5" name="Immagine 4" descr="Immagine che contiene linea, schermata, Diagramma, diagramma&#10;&#10;Descrizione generata automaticamente">
            <a:extLst>
              <a:ext uri="{FF2B5EF4-FFF2-40B4-BE49-F238E27FC236}">
                <a16:creationId xmlns:a16="http://schemas.microsoft.com/office/drawing/2014/main" id="{D9418DB5-A098-C893-7761-F7F524FD25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6688" y="2000249"/>
            <a:ext cx="10438623" cy="3131587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6728706E-3887-DA16-D7E2-DE21AABC0BA2}"/>
              </a:ext>
            </a:extLst>
          </p:cNvPr>
          <p:cNvSpPr txBox="1"/>
          <p:nvPr/>
        </p:nvSpPr>
        <p:spPr>
          <a:xfrm>
            <a:off x="769435" y="2631688"/>
            <a:ext cx="10370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solidFill>
                  <a:schemeClr val="bg2">
                    <a:lumMod val="25000"/>
                  </a:schemeClr>
                </a:solidFill>
              </a:rPr>
              <a:t>NORMAL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1C6A042-32E8-6C87-A979-C50DF0478763}"/>
              </a:ext>
            </a:extLst>
          </p:cNvPr>
          <p:cNvSpPr txBox="1"/>
          <p:nvPr/>
        </p:nvSpPr>
        <p:spPr>
          <a:xfrm>
            <a:off x="769435" y="3881762"/>
            <a:ext cx="10370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solidFill>
                  <a:schemeClr val="bg2">
                    <a:lumMod val="25000"/>
                  </a:schemeClr>
                </a:solidFill>
              </a:rPr>
              <a:t>UNIFORM</a:t>
            </a:r>
          </a:p>
        </p:txBody>
      </p:sp>
    </p:spTree>
    <p:extLst>
      <p:ext uri="{BB962C8B-B14F-4D97-AF65-F5344CB8AC3E}">
        <p14:creationId xmlns:p14="http://schemas.microsoft.com/office/powerpoint/2010/main" val="24783297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4E9CA7-260C-EAAC-7EE1-1B02DD2911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68122647-0A5D-EE49-D88E-9EE08D88ACAB}"/>
              </a:ext>
            </a:extLst>
          </p:cNvPr>
          <p:cNvSpPr txBox="1"/>
          <p:nvPr/>
        </p:nvSpPr>
        <p:spPr>
          <a:xfrm>
            <a:off x="52613" y="6420758"/>
            <a:ext cx="2951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2B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 descr="Immagine che contiene linea, Diagramma, schermata, diagramma&#10;&#10;Descrizione generata automaticamente">
            <a:extLst>
              <a:ext uri="{FF2B5EF4-FFF2-40B4-BE49-F238E27FC236}">
                <a16:creationId xmlns:a16="http://schemas.microsoft.com/office/drawing/2014/main" id="{AE42C4B1-44B8-E8F2-2000-832B950ABE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468" y="2168200"/>
            <a:ext cx="10127603" cy="3038281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FDDA3F7D-7593-BF72-FB30-6A5C68496CDC}"/>
              </a:ext>
            </a:extLst>
          </p:cNvPr>
          <p:cNvSpPr txBox="1"/>
          <p:nvPr/>
        </p:nvSpPr>
        <p:spPr>
          <a:xfrm>
            <a:off x="514605" y="2781588"/>
            <a:ext cx="10370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solidFill>
                  <a:schemeClr val="bg2">
                    <a:lumMod val="25000"/>
                  </a:schemeClr>
                </a:solidFill>
              </a:rPr>
              <a:t>NORMAL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D6B5EDB6-DC83-B2A2-75EB-FE2B609C64EA}"/>
              </a:ext>
            </a:extLst>
          </p:cNvPr>
          <p:cNvSpPr txBox="1"/>
          <p:nvPr/>
        </p:nvSpPr>
        <p:spPr>
          <a:xfrm>
            <a:off x="514605" y="3926732"/>
            <a:ext cx="10370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solidFill>
                  <a:schemeClr val="bg2">
                    <a:lumMod val="25000"/>
                  </a:schemeClr>
                </a:solidFill>
              </a:rPr>
              <a:t>UNIFORM</a:t>
            </a:r>
          </a:p>
        </p:txBody>
      </p:sp>
    </p:spTree>
    <p:extLst>
      <p:ext uri="{BB962C8B-B14F-4D97-AF65-F5344CB8AC3E}">
        <p14:creationId xmlns:p14="http://schemas.microsoft.com/office/powerpoint/2010/main" val="33395924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77</TotalTime>
  <Words>13</Words>
  <Application>Microsoft Macintosh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RAZIA PENNISI</dc:creator>
  <cp:lastModifiedBy>Salvatore Petta</cp:lastModifiedBy>
  <cp:revision>8</cp:revision>
  <dcterms:created xsi:type="dcterms:W3CDTF">2024-01-03T17:09:20Z</dcterms:created>
  <dcterms:modified xsi:type="dcterms:W3CDTF">2024-07-06T12:37:49Z</dcterms:modified>
</cp:coreProperties>
</file>